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  <p:sldId id="257" r:id="rId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4" autoAdjust="0"/>
    <p:restoredTop sz="94660"/>
  </p:normalViewPr>
  <p:slideViewPr>
    <p:cSldViewPr snapToGrid="0">
      <p:cViewPr varScale="1">
        <p:scale>
          <a:sx n="86" d="100"/>
          <a:sy n="86" d="100"/>
        </p:scale>
        <p:origin x="562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BE845B2-9D54-48FC-B694-805B1BE6236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4715FEF9-8940-44B9-8059-268DC3C9DA4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9CEDE5E-7D7C-4372-9611-D2B8728775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DCA1FC-4161-42A7-B300-A3E14B6A594B}" type="datetimeFigureOut">
              <a:rPr lang="zh-CN" altLang="en-US" smtClean="0"/>
              <a:t>2021/10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F4CD1DC-E070-49BE-9FE0-AEC5C3964B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2A17E91-B32B-4707-908C-08DBA63BA4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7558C-B8B0-4B96-974B-6F07CF10E6C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400650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D785CE5-A35B-4186-A2F3-C2D7426F698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D03B8F70-1E42-4DC5-9A17-08B67BB429E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DFAFAAC-E5A4-4D01-B2D2-1ADDEEA6BF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DCA1FC-4161-42A7-B300-A3E14B6A594B}" type="datetimeFigureOut">
              <a:rPr lang="zh-CN" altLang="en-US" smtClean="0"/>
              <a:t>2021/10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BEDF4E1-11B6-444A-BB75-A06F9F2C8F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4CF9007-6569-4A6C-8D62-48BE910123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7558C-B8B0-4B96-974B-6F07CF10E6C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397175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CF8DC966-672C-4453-AAF9-35C6F8FD789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F58C91FC-614C-4C94-8992-31BFA9F930D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24D6217-51AD-4EBD-BA1B-EF529B4674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DCA1FC-4161-42A7-B300-A3E14B6A594B}" type="datetimeFigureOut">
              <a:rPr lang="zh-CN" altLang="en-US" smtClean="0"/>
              <a:t>2021/10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59B0FF9-AAEF-4394-87B4-ECC3A15F67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E9ED32A-9FE8-4667-AD7D-0B0FB4207A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7558C-B8B0-4B96-974B-6F07CF10E6C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482842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69F1D28-D621-446E-98D5-9739791F09D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1E9BE86-6926-4430-92AB-A432D836A56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0AFE680-52C0-46AC-BF89-9AF0725758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DCA1FC-4161-42A7-B300-A3E14B6A594B}" type="datetimeFigureOut">
              <a:rPr lang="zh-CN" altLang="en-US" smtClean="0"/>
              <a:t>2021/10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809DE23-9735-4E29-BC32-D91D9FAF74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5B167D4-351F-4097-9B00-265853F8E4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7558C-B8B0-4B96-974B-6F07CF10E6C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235564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7C6CCDC-2E39-42A2-9DE9-7EBD6643AB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C99BD01-2D12-43D3-82D1-B56A8323C82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5C6F414-7767-4EC0-BC66-0DD916F3CA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DCA1FC-4161-42A7-B300-A3E14B6A594B}" type="datetimeFigureOut">
              <a:rPr lang="zh-CN" altLang="en-US" smtClean="0"/>
              <a:t>2021/10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4CB3090-C5F3-4F2D-B144-B70A3DD9D9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17E7620-7E72-4137-B119-9F210D5A35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7558C-B8B0-4B96-974B-6F07CF10E6C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619766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38EC3A0-72F3-4058-B9BA-2EDA7000CB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A227F92-347F-4554-B0AA-7747C53F08C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CB372951-8E4D-4EA2-A13E-212289C5DFB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CB4998A-B853-4D1E-A80B-65C9C43ED9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DCA1FC-4161-42A7-B300-A3E14B6A594B}" type="datetimeFigureOut">
              <a:rPr lang="zh-CN" altLang="en-US" smtClean="0"/>
              <a:t>2021/10/1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678A9E3A-C373-4301-BD5E-C8E7A4769E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8CA3DDF6-6C15-4793-A116-6CC6879DE6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7558C-B8B0-4B96-974B-6F07CF10E6C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664880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ABF947A-702C-4E4A-8BD6-747157D9B1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0E55D40-9BB1-4269-968A-C0CF6B5BC68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14A71ED6-6929-487C-99B4-38ECC25066C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62701C7F-A3C4-4142-8D40-141E17FC029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11A3D290-DD80-4A48-A9C5-60399C85F4A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924EC232-91C6-4491-B78F-649002EC70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DCA1FC-4161-42A7-B300-A3E14B6A594B}" type="datetimeFigureOut">
              <a:rPr lang="zh-CN" altLang="en-US" smtClean="0"/>
              <a:t>2021/10/18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FFBAF67B-C1AE-49D1-94C8-FF8712B23F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1507E90E-4D5E-430F-A77B-A4D1E71F0B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7558C-B8B0-4B96-974B-6F07CF10E6C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817531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CCE7586-E9CA-441B-95BF-991AF0479F0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056CC3C9-BE72-4754-9079-5351C60BDD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DCA1FC-4161-42A7-B300-A3E14B6A594B}" type="datetimeFigureOut">
              <a:rPr lang="zh-CN" altLang="en-US" smtClean="0"/>
              <a:t>2021/10/18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2AF18850-BFFC-42DA-AD83-EC56DDBE4B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15849B58-EA52-42F6-A4C4-C617D7BBF2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7558C-B8B0-4B96-974B-6F07CF10E6C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643138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37CA8775-E18A-4373-B2F4-5494C2C143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DCA1FC-4161-42A7-B300-A3E14B6A594B}" type="datetimeFigureOut">
              <a:rPr lang="zh-CN" altLang="en-US" smtClean="0"/>
              <a:t>2021/10/18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AE93C2F2-9D68-43D0-8682-62D30DB064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52C71195-38D1-4A85-BD3A-D462E4E110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7558C-B8B0-4B96-974B-6F07CF10E6C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69597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06F0A78-FF90-4AD1-A4AE-F346950A73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A3F57B2-7E05-460F-A5EA-7FCDBD290AF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48498FEA-1E71-46E6-9967-AADCF106EC9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C902BAF-1AE4-4DF4-8891-8AF31B55D3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DCA1FC-4161-42A7-B300-A3E14B6A594B}" type="datetimeFigureOut">
              <a:rPr lang="zh-CN" altLang="en-US" smtClean="0"/>
              <a:t>2021/10/1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B538730-A95F-4035-A8D4-85E5EDBEFE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F0C12F1-D168-4CED-B0A0-48A6701ABC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7558C-B8B0-4B96-974B-6F07CF10E6C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031170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CE98DF1-429A-4718-AB6F-74936E11998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5B617677-9DDE-405C-85C5-5A8A015DA0D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AE3ADDC4-E35C-4917-9E4F-BA9D8EF9D88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5C73C4D-1388-4E44-8063-F286BD36F2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DCA1FC-4161-42A7-B300-A3E14B6A594B}" type="datetimeFigureOut">
              <a:rPr lang="zh-CN" altLang="en-US" smtClean="0"/>
              <a:t>2021/10/1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51C4A33-3FCD-4617-B444-AC1ABF2B2A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76228E0-A4B6-4478-8103-2FD7FF8DA6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7558C-B8B0-4B96-974B-6F07CF10E6C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188320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DDB2F3C4-D841-4C4E-9AFF-05AA480709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73A995A4-9CF6-4490-881B-29C765C66C9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C52CF23-868D-457D-8F8B-42C51716836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DCA1FC-4161-42A7-B300-A3E14B6A594B}" type="datetimeFigureOut">
              <a:rPr lang="zh-CN" altLang="en-US" smtClean="0"/>
              <a:t>2021/10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1BE1F0C-9FA7-4B51-9961-C95D1E1D595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C1479BC-9298-49E0-9441-F0B483796E9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07558C-B8B0-4B96-974B-6F07CF10E6C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174896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g"/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5.jpg"/><Relationship Id="rId4" Type="http://schemas.openxmlformats.org/officeDocument/2006/relationships/image" Target="../media/image4.jp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g"/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" name="图片 24">
            <a:extLst>
              <a:ext uri="{FF2B5EF4-FFF2-40B4-BE49-F238E27FC236}">
                <a16:creationId xmlns:a16="http://schemas.microsoft.com/office/drawing/2014/main" id="{D102663B-CD60-43C3-AF58-684BCFB6582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84330"/>
          <a:stretch/>
        </p:blipFill>
        <p:spPr>
          <a:xfrm>
            <a:off x="8349559" y="3269690"/>
            <a:ext cx="3047577" cy="1074673"/>
          </a:xfrm>
          <a:prstGeom prst="rect">
            <a:avLst/>
          </a:prstGeom>
        </p:spPr>
      </p:pic>
      <p:pic>
        <p:nvPicPr>
          <p:cNvPr id="27" name="图片 26">
            <a:extLst>
              <a:ext uri="{FF2B5EF4-FFF2-40B4-BE49-F238E27FC236}">
                <a16:creationId xmlns:a16="http://schemas.microsoft.com/office/drawing/2014/main" id="{ECE5D1A2-7E41-4DFD-AF47-BF29ED35D54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7607" b="38783"/>
          <a:stretch/>
        </p:blipFill>
        <p:spPr>
          <a:xfrm>
            <a:off x="8336494" y="2707137"/>
            <a:ext cx="3047577" cy="933326"/>
          </a:xfrm>
          <a:prstGeom prst="rect">
            <a:avLst/>
          </a:prstGeom>
        </p:spPr>
      </p:pic>
      <p:pic>
        <p:nvPicPr>
          <p:cNvPr id="26" name="图片 25">
            <a:extLst>
              <a:ext uri="{FF2B5EF4-FFF2-40B4-BE49-F238E27FC236}">
                <a16:creationId xmlns:a16="http://schemas.microsoft.com/office/drawing/2014/main" id="{0FA912FA-DAE2-443F-8827-DDFA3C13E305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4305" b="52086"/>
          <a:stretch/>
        </p:blipFill>
        <p:spPr>
          <a:xfrm>
            <a:off x="8336494" y="1906288"/>
            <a:ext cx="3047577" cy="933326"/>
          </a:xfrm>
          <a:prstGeom prst="rect">
            <a:avLst/>
          </a:prstGeom>
        </p:spPr>
      </p:pic>
      <p:grpSp>
        <p:nvGrpSpPr>
          <p:cNvPr id="2" name="组合 1">
            <a:extLst>
              <a:ext uri="{FF2B5EF4-FFF2-40B4-BE49-F238E27FC236}">
                <a16:creationId xmlns:a16="http://schemas.microsoft.com/office/drawing/2014/main" id="{A43693B2-B1DF-442E-AAD6-AE9AFE50BEF3}"/>
              </a:ext>
            </a:extLst>
          </p:cNvPr>
          <p:cNvGrpSpPr/>
          <p:nvPr/>
        </p:nvGrpSpPr>
        <p:grpSpPr>
          <a:xfrm>
            <a:off x="980716" y="1447695"/>
            <a:ext cx="8521955" cy="2790483"/>
            <a:chOff x="-511405" y="394284"/>
            <a:chExt cx="9072362" cy="3210078"/>
          </a:xfrm>
        </p:grpSpPr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B6344D30-D58A-43FC-8591-2F04136C5650}"/>
                </a:ext>
              </a:extLst>
            </p:cNvPr>
            <p:cNvSpPr txBox="1"/>
            <p:nvPr/>
          </p:nvSpPr>
          <p:spPr>
            <a:xfrm>
              <a:off x="2097247" y="394284"/>
              <a:ext cx="466225" cy="42486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/>
                <a:t>S1</a:t>
              </a:r>
              <a:endParaRPr lang="zh-CN" altLang="en-US" b="1" dirty="0"/>
            </a:p>
          </p:txBody>
        </p:sp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DE4078C7-841F-42EF-9E9D-6D7F5C33AF4F}"/>
                </a:ext>
              </a:extLst>
            </p:cNvPr>
            <p:cNvSpPr txBox="1"/>
            <p:nvPr/>
          </p:nvSpPr>
          <p:spPr>
            <a:xfrm>
              <a:off x="8094732" y="578950"/>
              <a:ext cx="466225" cy="42486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/>
                <a:t>S2</a:t>
              </a:r>
              <a:endParaRPr lang="zh-CN" altLang="en-US" b="1" dirty="0"/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BB4D0C81-B29A-491D-AEAF-0DD3ECFE2086}"/>
                </a:ext>
              </a:extLst>
            </p:cNvPr>
            <p:cNvSpPr txBox="1"/>
            <p:nvPr/>
          </p:nvSpPr>
          <p:spPr>
            <a:xfrm>
              <a:off x="303221" y="3235030"/>
              <a:ext cx="97013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/>
                <a:t>GAPDH</a:t>
              </a:r>
              <a:endParaRPr lang="zh-CN" altLang="en-US" b="1" dirty="0"/>
            </a:p>
          </p:txBody>
        </p: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9E7A19E1-7D92-440C-BD57-3D62F54A01AF}"/>
                </a:ext>
              </a:extLst>
            </p:cNvPr>
            <p:cNvSpPr txBox="1"/>
            <p:nvPr/>
          </p:nvSpPr>
          <p:spPr>
            <a:xfrm>
              <a:off x="5630102" y="1319814"/>
              <a:ext cx="2200066" cy="42486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800" b="1" dirty="0"/>
                <a:t>cleaved-Caspase3</a:t>
              </a:r>
              <a:endParaRPr lang="zh-CN" altLang="en-US" b="1" dirty="0"/>
            </a:p>
          </p:txBody>
        </p: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AF601DB9-1B21-4655-A389-AA3009E9B1E0}"/>
                </a:ext>
              </a:extLst>
            </p:cNvPr>
            <p:cNvSpPr txBox="1"/>
            <p:nvPr/>
          </p:nvSpPr>
          <p:spPr>
            <a:xfrm>
              <a:off x="6539054" y="3026574"/>
              <a:ext cx="97013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/>
                <a:t>GAPDH</a:t>
              </a:r>
              <a:endParaRPr lang="zh-CN" altLang="en-US" b="1" dirty="0"/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225511C9-305D-4E47-9734-4BF636374376}"/>
                </a:ext>
              </a:extLst>
            </p:cNvPr>
            <p:cNvSpPr txBox="1"/>
            <p:nvPr/>
          </p:nvSpPr>
          <p:spPr>
            <a:xfrm>
              <a:off x="-511405" y="1033800"/>
              <a:ext cx="2200066" cy="42486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/>
                <a:t>cleaved-Caspase3</a:t>
              </a:r>
              <a:endParaRPr lang="zh-CN" altLang="en-US" b="1" dirty="0"/>
            </a:p>
          </p:txBody>
        </p:sp>
      </p:grpSp>
      <p:sp>
        <p:nvSpPr>
          <p:cNvPr id="24" name="文本框 23">
            <a:extLst>
              <a:ext uri="{FF2B5EF4-FFF2-40B4-BE49-F238E27FC236}">
                <a16:creationId xmlns:a16="http://schemas.microsoft.com/office/drawing/2014/main" id="{FE303D8E-58C7-4A15-AB10-2A306638F20F}"/>
              </a:ext>
            </a:extLst>
          </p:cNvPr>
          <p:cNvSpPr txBox="1"/>
          <p:nvPr/>
        </p:nvSpPr>
        <p:spPr>
          <a:xfrm>
            <a:off x="195974" y="265009"/>
            <a:ext cx="1039508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Figure 2 Role of SNHG6 in DDP resistance, proliferation and metastasis of DDP-resistant GC cells.</a:t>
            </a:r>
            <a:endParaRPr lang="zh-CN" altLang="en-US" dirty="0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6DD3B80B-DA44-4D47-BE08-4693735EB25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626" b="68620"/>
          <a:stretch/>
        </p:blipFill>
        <p:spPr>
          <a:xfrm>
            <a:off x="2667214" y="3539713"/>
            <a:ext cx="3047577" cy="943260"/>
          </a:xfrm>
          <a:prstGeom prst="rect">
            <a:avLst/>
          </a:prstGeom>
        </p:spPr>
      </p:pic>
      <p:pic>
        <p:nvPicPr>
          <p:cNvPr id="30" name="图片 29">
            <a:extLst>
              <a:ext uri="{FF2B5EF4-FFF2-40B4-BE49-F238E27FC236}">
                <a16:creationId xmlns:a16="http://schemas.microsoft.com/office/drawing/2014/main" id="{9C3B8DBD-751B-4E23-B3D2-B30AA763EBA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848" t="79210"/>
          <a:stretch/>
        </p:blipFill>
        <p:spPr>
          <a:xfrm>
            <a:off x="2955820" y="1906288"/>
            <a:ext cx="2656038" cy="1425754"/>
          </a:xfrm>
          <a:prstGeom prst="rect">
            <a:avLst/>
          </a:prstGeom>
        </p:spPr>
      </p:pic>
      <p:pic>
        <p:nvPicPr>
          <p:cNvPr id="28" name="图片 27">
            <a:extLst>
              <a:ext uri="{FF2B5EF4-FFF2-40B4-BE49-F238E27FC236}">
                <a16:creationId xmlns:a16="http://schemas.microsoft.com/office/drawing/2014/main" id="{DA947AAF-F5CC-4928-A35A-B2361C08109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2550" b="21738"/>
          <a:stretch/>
        </p:blipFill>
        <p:spPr>
          <a:xfrm>
            <a:off x="2760435" y="2583507"/>
            <a:ext cx="3047577" cy="1077531"/>
          </a:xfrm>
          <a:prstGeom prst="rect">
            <a:avLst/>
          </a:prstGeom>
        </p:spPr>
      </p:pic>
      <p:sp>
        <p:nvSpPr>
          <p:cNvPr id="31" name="文本框 30">
            <a:extLst>
              <a:ext uri="{FF2B5EF4-FFF2-40B4-BE49-F238E27FC236}">
                <a16:creationId xmlns:a16="http://schemas.microsoft.com/office/drawing/2014/main" id="{2EB94DAD-1B55-4E70-B655-BCBDC4F33635}"/>
              </a:ext>
            </a:extLst>
          </p:cNvPr>
          <p:cNvSpPr txBox="1"/>
          <p:nvPr/>
        </p:nvSpPr>
        <p:spPr>
          <a:xfrm>
            <a:off x="1168264" y="2987923"/>
            <a:ext cx="16353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pro-Caspase3</a:t>
            </a:r>
            <a:endParaRPr lang="zh-CN" altLang="en-US" b="1" dirty="0"/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D2FFF91C-74AA-40F9-837F-4C9FDC2D5CF3}"/>
              </a:ext>
            </a:extLst>
          </p:cNvPr>
          <p:cNvSpPr txBox="1"/>
          <p:nvPr/>
        </p:nvSpPr>
        <p:spPr>
          <a:xfrm>
            <a:off x="6824268" y="2914945"/>
            <a:ext cx="16353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pro-Caspase3</a:t>
            </a:r>
            <a:endParaRPr lang="zh-CN" altLang="en-US" b="1" dirty="0"/>
          </a:p>
        </p:txBody>
      </p:sp>
    </p:spTree>
    <p:extLst>
      <p:ext uri="{BB962C8B-B14F-4D97-AF65-F5344CB8AC3E}">
        <p14:creationId xmlns:p14="http://schemas.microsoft.com/office/powerpoint/2010/main" val="245565735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:a16="http://schemas.microsoft.com/office/drawing/2014/main" id="{A43693B2-B1DF-442E-AAD6-AE9AFE50BEF3}"/>
              </a:ext>
            </a:extLst>
          </p:cNvPr>
          <p:cNvGrpSpPr/>
          <p:nvPr/>
        </p:nvGrpSpPr>
        <p:grpSpPr>
          <a:xfrm>
            <a:off x="231340" y="1065320"/>
            <a:ext cx="9640629" cy="5690060"/>
            <a:chOff x="231340" y="209726"/>
            <a:chExt cx="10263288" cy="6545654"/>
          </a:xfrm>
        </p:grpSpPr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5A797A1E-7E60-4CC5-B3B4-93E1CEB38A7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588" t="20184" r="25735" b="50000"/>
            <a:stretch/>
          </p:blipFill>
          <p:spPr>
            <a:xfrm>
              <a:off x="231340" y="209726"/>
              <a:ext cx="4538444" cy="3435548"/>
            </a:xfrm>
            <a:prstGeom prst="rect">
              <a:avLst/>
            </a:prstGeom>
          </p:spPr>
        </p:pic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B6344D30-D58A-43FC-8591-2F04136C5650}"/>
                </a:ext>
              </a:extLst>
            </p:cNvPr>
            <p:cNvSpPr txBox="1"/>
            <p:nvPr/>
          </p:nvSpPr>
          <p:spPr>
            <a:xfrm>
              <a:off x="2097247" y="394284"/>
              <a:ext cx="83548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/>
                <a:t>Fig 5C</a:t>
              </a:r>
              <a:endParaRPr lang="zh-CN" altLang="en-US" b="1" dirty="0"/>
            </a:p>
          </p:txBody>
        </p:sp>
        <p:pic>
          <p:nvPicPr>
            <p:cNvPr id="8" name="图片 7">
              <a:extLst>
                <a:ext uri="{FF2B5EF4-FFF2-40B4-BE49-F238E27FC236}">
                  <a16:creationId xmlns:a16="http://schemas.microsoft.com/office/drawing/2014/main" id="{36AC50F4-300D-43C4-B7FB-49C344A4EA1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686" t="23975" r="28501" b="46847"/>
            <a:stretch/>
          </p:blipFill>
          <p:spPr>
            <a:xfrm>
              <a:off x="6501468" y="578950"/>
              <a:ext cx="3993160" cy="3004704"/>
            </a:xfrm>
            <a:prstGeom prst="rect">
              <a:avLst/>
            </a:prstGeom>
          </p:spPr>
        </p:pic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DE4078C7-841F-42EF-9E9D-6D7F5C33AF4F}"/>
                </a:ext>
              </a:extLst>
            </p:cNvPr>
            <p:cNvSpPr txBox="1"/>
            <p:nvPr/>
          </p:nvSpPr>
          <p:spPr>
            <a:xfrm>
              <a:off x="8094732" y="578950"/>
              <a:ext cx="85792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/>
                <a:t>Fig 5D</a:t>
              </a:r>
              <a:endParaRPr lang="zh-CN" altLang="en-US" b="1" dirty="0"/>
            </a:p>
          </p:txBody>
        </p:sp>
        <p:pic>
          <p:nvPicPr>
            <p:cNvPr id="11" name="图片 10">
              <a:extLst>
                <a:ext uri="{FF2B5EF4-FFF2-40B4-BE49-F238E27FC236}">
                  <a16:creationId xmlns:a16="http://schemas.microsoft.com/office/drawing/2014/main" id="{AB14BE00-1A64-45D6-BCD8-B0DA4AF635A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726" t="20145" r="24116" b="49605"/>
            <a:stretch/>
          </p:blipFill>
          <p:spPr>
            <a:xfrm>
              <a:off x="642400" y="3645274"/>
              <a:ext cx="3993160" cy="3095536"/>
            </a:xfrm>
            <a:prstGeom prst="rect">
              <a:avLst/>
            </a:prstGeom>
          </p:spPr>
        </p:pic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B4D9CA79-760C-4C4D-9B0C-B7219C780E01}"/>
                </a:ext>
              </a:extLst>
            </p:cNvPr>
            <p:cNvSpPr txBox="1"/>
            <p:nvPr/>
          </p:nvSpPr>
          <p:spPr>
            <a:xfrm>
              <a:off x="2227649" y="3653881"/>
              <a:ext cx="77938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/>
                <a:t>Fig 5E</a:t>
              </a:r>
              <a:endParaRPr lang="zh-CN" altLang="en-US" dirty="0"/>
            </a:p>
          </p:txBody>
        </p:sp>
        <p:pic>
          <p:nvPicPr>
            <p:cNvPr id="14" name="图片 13">
              <a:extLst>
                <a:ext uri="{FF2B5EF4-FFF2-40B4-BE49-F238E27FC236}">
                  <a16:creationId xmlns:a16="http://schemas.microsoft.com/office/drawing/2014/main" id="{0CFBFED7-34FD-48B8-B4D4-97480582BEA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665" t="22875" r="30231" b="49999"/>
            <a:stretch/>
          </p:blipFill>
          <p:spPr>
            <a:xfrm>
              <a:off x="6589925" y="3645274"/>
              <a:ext cx="3820813" cy="3110106"/>
            </a:xfrm>
            <a:prstGeom prst="rect">
              <a:avLst/>
            </a:prstGeom>
          </p:spPr>
        </p:pic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981CD29A-EEC8-4006-B7B0-C41FD42BEFF2}"/>
                </a:ext>
              </a:extLst>
            </p:cNvPr>
            <p:cNvSpPr txBox="1"/>
            <p:nvPr/>
          </p:nvSpPr>
          <p:spPr>
            <a:xfrm>
              <a:off x="8138012" y="3583654"/>
              <a:ext cx="80823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/>
                <a:t>Fig 5F</a:t>
              </a:r>
              <a:endParaRPr lang="zh-CN" altLang="en-US" b="1" dirty="0"/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225511C9-305D-4E47-9734-4BF636374376}"/>
                </a:ext>
              </a:extLst>
            </p:cNvPr>
            <p:cNvSpPr txBox="1"/>
            <p:nvPr/>
          </p:nvSpPr>
          <p:spPr>
            <a:xfrm>
              <a:off x="538293" y="1217804"/>
              <a:ext cx="73770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/>
                <a:t>Bcl-2</a:t>
              </a:r>
              <a:endParaRPr lang="zh-CN" altLang="en-US" b="1" dirty="0"/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BB4D0C81-B29A-491D-AEAF-0DD3ECFE2086}"/>
                </a:ext>
              </a:extLst>
            </p:cNvPr>
            <p:cNvSpPr txBox="1"/>
            <p:nvPr/>
          </p:nvSpPr>
          <p:spPr>
            <a:xfrm>
              <a:off x="310666" y="2431539"/>
              <a:ext cx="97013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/>
                <a:t>GAPDH</a:t>
              </a:r>
              <a:endParaRPr lang="zh-CN" altLang="en-US" b="1" dirty="0"/>
            </a:p>
          </p:txBody>
        </p: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9E7A19E1-7D92-440C-BD57-3D62F54A01AF}"/>
                </a:ext>
              </a:extLst>
            </p:cNvPr>
            <p:cNvSpPr txBox="1"/>
            <p:nvPr/>
          </p:nvSpPr>
          <p:spPr>
            <a:xfrm>
              <a:off x="6655272" y="1277925"/>
              <a:ext cx="73770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/>
                <a:t>Bcl-2</a:t>
              </a:r>
              <a:endParaRPr lang="zh-CN" altLang="en-US" b="1" dirty="0"/>
            </a:p>
          </p:txBody>
        </p: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AF601DB9-1B21-4655-A389-AA3009E9B1E0}"/>
                </a:ext>
              </a:extLst>
            </p:cNvPr>
            <p:cNvSpPr txBox="1"/>
            <p:nvPr/>
          </p:nvSpPr>
          <p:spPr>
            <a:xfrm>
              <a:off x="6449402" y="2379937"/>
              <a:ext cx="97013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/>
                <a:t>GAPDH</a:t>
              </a:r>
              <a:endParaRPr lang="zh-CN" altLang="en-US" b="1" dirty="0"/>
            </a:p>
          </p:txBody>
        </p:sp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30CE9621-E0B7-43DB-84B3-58DCBD78FC6E}"/>
                </a:ext>
              </a:extLst>
            </p:cNvPr>
            <p:cNvSpPr txBox="1"/>
            <p:nvPr/>
          </p:nvSpPr>
          <p:spPr>
            <a:xfrm>
              <a:off x="6681837" y="4408420"/>
              <a:ext cx="73770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/>
                <a:t>Bcl-2</a:t>
              </a:r>
              <a:endParaRPr lang="zh-CN" altLang="en-US" b="1" dirty="0"/>
            </a:p>
          </p:txBody>
        </p:sp>
        <p:sp>
          <p:nvSpPr>
            <p:cNvPr id="21" name="文本框 20">
              <a:extLst>
                <a:ext uri="{FF2B5EF4-FFF2-40B4-BE49-F238E27FC236}">
                  <a16:creationId xmlns:a16="http://schemas.microsoft.com/office/drawing/2014/main" id="{AE16A7FB-7DE7-4182-B356-341DA5E7D32F}"/>
                </a:ext>
              </a:extLst>
            </p:cNvPr>
            <p:cNvSpPr txBox="1"/>
            <p:nvPr/>
          </p:nvSpPr>
          <p:spPr>
            <a:xfrm>
              <a:off x="6454210" y="5622155"/>
              <a:ext cx="97013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/>
                <a:t>GAPDH</a:t>
              </a:r>
              <a:endParaRPr lang="zh-CN" altLang="en-US" b="1" dirty="0"/>
            </a:p>
          </p:txBody>
        </p:sp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8C2BA3EF-D797-4DE1-95E1-FB91D4C89FD1}"/>
                </a:ext>
              </a:extLst>
            </p:cNvPr>
            <p:cNvSpPr txBox="1"/>
            <p:nvPr/>
          </p:nvSpPr>
          <p:spPr>
            <a:xfrm>
              <a:off x="633368" y="4416809"/>
              <a:ext cx="73770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/>
                <a:t>Bcl-2</a:t>
              </a:r>
              <a:endParaRPr lang="zh-CN" altLang="en-US" b="1" dirty="0"/>
            </a:p>
          </p:txBody>
        </p:sp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98198274-513A-49C3-A094-9446A3BB1A62}"/>
                </a:ext>
              </a:extLst>
            </p:cNvPr>
            <p:cNvSpPr txBox="1"/>
            <p:nvPr/>
          </p:nvSpPr>
          <p:spPr>
            <a:xfrm>
              <a:off x="405741" y="5630544"/>
              <a:ext cx="97013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/>
                <a:t>GAPDH</a:t>
              </a:r>
              <a:endParaRPr lang="zh-CN" altLang="en-US" b="1" dirty="0"/>
            </a:p>
          </p:txBody>
        </p:sp>
      </p:grpSp>
      <p:sp>
        <p:nvSpPr>
          <p:cNvPr id="24" name="文本框 23">
            <a:extLst>
              <a:ext uri="{FF2B5EF4-FFF2-40B4-BE49-F238E27FC236}">
                <a16:creationId xmlns:a16="http://schemas.microsoft.com/office/drawing/2014/main" id="{FE303D8E-58C7-4A15-AB10-2A306638F20F}"/>
              </a:ext>
            </a:extLst>
          </p:cNvPr>
          <p:cNvSpPr txBox="1"/>
          <p:nvPr/>
        </p:nvSpPr>
        <p:spPr>
          <a:xfrm>
            <a:off x="195975" y="265009"/>
            <a:ext cx="609452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Figure 5 Identification of BCL-2 as a target of miR-1297.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80518380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:a16="http://schemas.microsoft.com/office/drawing/2014/main" id="{5A3D87B9-1DC4-48C6-986E-1E383EE763D4}"/>
              </a:ext>
            </a:extLst>
          </p:cNvPr>
          <p:cNvGrpSpPr/>
          <p:nvPr/>
        </p:nvGrpSpPr>
        <p:grpSpPr>
          <a:xfrm>
            <a:off x="1040264" y="1668953"/>
            <a:ext cx="9883457" cy="3644382"/>
            <a:chOff x="1501903" y="1606809"/>
            <a:chExt cx="9883457" cy="3644382"/>
          </a:xfrm>
        </p:grpSpPr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7FB5A8A5-43AE-4792-8917-52BD1DACFEF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709" t="21651" r="40432" b="50000"/>
            <a:stretch/>
          </p:blipFill>
          <p:spPr>
            <a:xfrm>
              <a:off x="1649834" y="1606809"/>
              <a:ext cx="4261607" cy="3644382"/>
            </a:xfrm>
            <a:prstGeom prst="rect">
              <a:avLst/>
            </a:prstGeom>
          </p:spPr>
        </p:pic>
        <p:pic>
          <p:nvPicPr>
            <p:cNvPr id="7" name="图片 6">
              <a:extLst>
                <a:ext uri="{FF2B5EF4-FFF2-40B4-BE49-F238E27FC236}">
                  <a16:creationId xmlns:a16="http://schemas.microsoft.com/office/drawing/2014/main" id="{39114B5E-2442-4049-9948-C56FB70E526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452" t="26055" r="36110" b="48624"/>
            <a:stretch/>
          </p:blipFill>
          <p:spPr>
            <a:xfrm>
              <a:off x="7396296" y="1822508"/>
              <a:ext cx="3989064" cy="3212983"/>
            </a:xfrm>
            <a:prstGeom prst="rect">
              <a:avLst/>
            </a:prstGeom>
          </p:spPr>
        </p:pic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37AAE6FF-1D67-4214-A14A-94D4AE2438BA}"/>
                </a:ext>
              </a:extLst>
            </p:cNvPr>
            <p:cNvSpPr txBox="1"/>
            <p:nvPr/>
          </p:nvSpPr>
          <p:spPr>
            <a:xfrm>
              <a:off x="3380763" y="1854076"/>
              <a:ext cx="84830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/>
                <a:t>Fig 6A</a:t>
              </a:r>
              <a:endParaRPr lang="zh-CN" altLang="en-US" b="1" dirty="0"/>
            </a:p>
          </p:txBody>
        </p:sp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D7F3A4F2-A503-4C9A-A528-D39C4788073B}"/>
                </a:ext>
              </a:extLst>
            </p:cNvPr>
            <p:cNvSpPr txBox="1"/>
            <p:nvPr/>
          </p:nvSpPr>
          <p:spPr>
            <a:xfrm>
              <a:off x="8782629" y="1854076"/>
              <a:ext cx="83227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/>
                <a:t>Fig 6B</a:t>
              </a:r>
              <a:endParaRPr lang="zh-CN" altLang="en-US" b="1" dirty="0"/>
            </a:p>
          </p:txBody>
        </p: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8DC0DB4E-C2A0-4972-BC6C-D4D38652F8C9}"/>
                </a:ext>
              </a:extLst>
            </p:cNvPr>
            <p:cNvSpPr txBox="1"/>
            <p:nvPr/>
          </p:nvSpPr>
          <p:spPr>
            <a:xfrm>
              <a:off x="1729530" y="2737717"/>
              <a:ext cx="73770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/>
                <a:t>Bcl-2</a:t>
              </a:r>
              <a:endParaRPr lang="zh-CN" altLang="en-US" b="1" dirty="0"/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C0278BCD-747E-494B-B409-82666C4958C0}"/>
                </a:ext>
              </a:extLst>
            </p:cNvPr>
            <p:cNvSpPr txBox="1"/>
            <p:nvPr/>
          </p:nvSpPr>
          <p:spPr>
            <a:xfrm>
              <a:off x="1501903" y="3951452"/>
              <a:ext cx="97013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/>
                <a:t>GAPDH</a:t>
              </a:r>
              <a:endParaRPr lang="zh-CN" altLang="en-US" b="1" dirty="0"/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B968A456-7FF2-49FF-8587-A18547B9BEA2}"/>
                </a:ext>
              </a:extLst>
            </p:cNvPr>
            <p:cNvSpPr txBox="1"/>
            <p:nvPr/>
          </p:nvSpPr>
          <p:spPr>
            <a:xfrm>
              <a:off x="7250890" y="2553051"/>
              <a:ext cx="73770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/>
                <a:t>Bcl-2</a:t>
              </a:r>
              <a:endParaRPr lang="zh-CN" altLang="en-US" b="1" dirty="0"/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F52A5DC8-876A-4590-BA3C-334B21A912FE}"/>
                </a:ext>
              </a:extLst>
            </p:cNvPr>
            <p:cNvSpPr txBox="1"/>
            <p:nvPr/>
          </p:nvSpPr>
          <p:spPr>
            <a:xfrm>
              <a:off x="7023263" y="3766786"/>
              <a:ext cx="97013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/>
                <a:t>GAPDH</a:t>
              </a:r>
              <a:endParaRPr lang="zh-CN" altLang="en-US" b="1" dirty="0"/>
            </a:p>
          </p:txBody>
        </p:sp>
      </p:grpSp>
      <p:sp>
        <p:nvSpPr>
          <p:cNvPr id="14" name="文本框 13">
            <a:extLst>
              <a:ext uri="{FF2B5EF4-FFF2-40B4-BE49-F238E27FC236}">
                <a16:creationId xmlns:a16="http://schemas.microsoft.com/office/drawing/2014/main" id="{2C7D182B-7C26-4508-85C9-BF79D92925A3}"/>
              </a:ext>
            </a:extLst>
          </p:cNvPr>
          <p:cNvSpPr txBox="1"/>
          <p:nvPr/>
        </p:nvSpPr>
        <p:spPr>
          <a:xfrm>
            <a:off x="195975" y="265009"/>
            <a:ext cx="11344996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Figure 6 Co-effect of </a:t>
            </a:r>
            <a:r>
              <a:rPr lang="en-US" altLang="zh-CN" sz="18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miR-1297 and BCL-2 on DDP resistance, proliferation and metastasis of DDP-resistant GC cells.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9140124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</TotalTime>
  <Words>79</Words>
  <Application>Microsoft Office PowerPoint</Application>
  <PresentationFormat>宽屏</PresentationFormat>
  <Paragraphs>29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8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izc</dc:creator>
  <cp:lastModifiedBy>李 志超</cp:lastModifiedBy>
  <cp:revision>6</cp:revision>
  <dcterms:created xsi:type="dcterms:W3CDTF">2021-01-18T17:50:27Z</dcterms:created>
  <dcterms:modified xsi:type="dcterms:W3CDTF">2021-10-18T04:45:16Z</dcterms:modified>
</cp:coreProperties>
</file>